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CABEC6-38CD-4A02-B990-87A5BCFB285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4A1F6F-FDEC-497E-8312-19427276AC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6CDAAE-1CD5-425C-BD9B-20363A98DE2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7A46D3-3952-411D-8CA3-D6E42A79880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A94059-6C27-4029-BD6A-D969E6A38F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A664C7-A883-4692-B419-644CD65469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B8CEA1-5C9A-45E9-8A43-C2D6466EE7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899252-2498-412A-972D-75E6908043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D1AF98-165D-4318-8EEC-5DAAF09BD0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3031AB-155C-444B-9B31-071DFE169A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C49B32-7516-4D1E-B4A6-4A0EA26FD7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34C26E-2C78-43E4-A81D-CC51430A1D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7A5DD0-046A-43C5-8A7A-34E4BEA219E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197000" y="631800"/>
          <a:ext cx="4248000" cy="5510160"/>
        </p:xfrm>
        <a:graphic>
          <a:graphicData uri="http://schemas.openxmlformats.org/drawingml/2006/table">
            <a:tbl>
              <a:tblPr/>
              <a:tblGrid>
                <a:gridCol w="1081080"/>
                <a:gridCol w="934920"/>
                <a:gridCol w="2232000"/>
              </a:tblGrid>
              <a:tr h="3952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GB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EF1A2</a:t>
                      </a: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ex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imer nam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imer sequence (5’ – 3’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698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xon1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TAGGGAGAGCCCCTCAG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xon1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GGTCAGTGGAGAAACC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F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TCTCCCCACCACCAC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26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R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GAGTTGGGGGTTCCTT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TGTAACAAGCAGCTCGC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CTGCTCACCTGGGA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26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GAGAGGCCTGGAAGTG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00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R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TCTCGCTGTAGGCCGG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F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TACACGCTGGGTGTGA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R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GAACCTGCATTTCCCG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26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F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CAGTACTCCTGGAAG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R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CTAGGGCAGGCAGAG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26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F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GCTCTGTCCCCGAATA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R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CAGTCCTGCTGCTGT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F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CAGATTAGCGCCGGCT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26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TGGATCAGCCACAGCC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TCCAGTCAGCACTCC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R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AGCTTCTTGCCAGAGC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AAGCGTGTTCCGAGGAC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26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CTCTGCCCTGAGTAGCC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1844640" y="6176880"/>
            <a:ext cx="345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able S1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PCR Primers used for mutation analysi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3" name=""/>
          <p:cNvGraphicFramePr/>
          <p:nvPr/>
        </p:nvGraphicFramePr>
        <p:xfrm>
          <a:off x="765000" y="704880"/>
          <a:ext cx="5329440" cy="4573440"/>
        </p:xfrm>
        <a:graphic>
          <a:graphicData uri="http://schemas.openxmlformats.org/drawingml/2006/table">
            <a:tbl>
              <a:tblPr/>
              <a:tblGrid>
                <a:gridCol w="1081440"/>
                <a:gridCol w="1081080"/>
                <a:gridCol w="934920"/>
                <a:gridCol w="2232000"/>
              </a:tblGrid>
              <a:tr h="398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GB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EF1A2</a:t>
                      </a: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Ex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CR Primer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quencing Primer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imer sequence (5’ – 3’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02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F + 1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F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R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CCGTCTTTGCAGCCCGC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CCCTCTTCGGAAGACG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02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FC + 2R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t2F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R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CAGAATCACTGC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02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F + 2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t3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CAGGGACTCCTGGGTC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981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F + 4R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F2 + 4R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R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t4F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R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CTCATCGTGGGCGTGA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02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F2 + 5R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t5F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t5R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GCCTGAGGGTGGGG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CCAGCACAGCGCCCTT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02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FB + 6R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t6F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R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CCCCAGCATCCCCTC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981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F1 + 7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F + 7R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t7F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t7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t7F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GTCATCGACTGCCACAC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TGCAGGGGCGCCGGTG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GTCATCGACTGCCACAC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02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F + 8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F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R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CGTGTTCCGAGGACATT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GGGAGTGAAGGATGCT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4" name=""/>
          <p:cNvGraphicFramePr/>
          <p:nvPr/>
        </p:nvGraphicFramePr>
        <p:xfrm>
          <a:off x="1341360" y="6032520"/>
          <a:ext cx="3960720" cy="1519200"/>
        </p:xfrm>
        <a:graphic>
          <a:graphicData uri="http://schemas.openxmlformats.org/drawingml/2006/table">
            <a:tbl>
              <a:tblPr/>
              <a:tblGrid>
                <a:gridCol w="1080720"/>
                <a:gridCol w="2087640"/>
                <a:gridCol w="792360"/>
              </a:tblGrid>
              <a:tr h="5508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imer Nam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quence (5’ – 3’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ze of amplified produ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A2 F2-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AAGGCTCTGGAACTCT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3b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A2 R2-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GACAAGTGAGGGCAGTA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A2 F3-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CTCTGGCATCTGAACC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2b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A2 R3-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ATGTATGAAGGTGTGT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5" name=""/>
          <p:cNvSpPr/>
          <p:nvPr/>
        </p:nvSpPr>
        <p:spPr>
          <a:xfrm>
            <a:off x="836640" y="5313240"/>
            <a:ext cx="52563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able S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. Sequencing primers used for mutation analysis. Primer sequences not listed are to be found in table S1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844640" y="7616880"/>
            <a:ext cx="345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able S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. Primers used for copy number analysis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4-02T13:51:41Z</dcterms:created>
  <dc:creator>Helen Newbery</dc:creator>
  <dc:description/>
  <dc:language>en-US</dc:language>
  <cp:lastModifiedBy>Helen Newbery</cp:lastModifiedBy>
  <dcterms:modified xsi:type="dcterms:W3CDTF">2007-04-02T16:09:06Z</dcterms:modified>
  <cp:revision>3</cp:revision>
  <dc:subject/>
  <dc:title>Slide 1</dc:title>
</cp:coreProperties>
</file>